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8" d="100"/>
          <a:sy n="158" d="100"/>
        </p:scale>
        <p:origin x="-228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09.12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116633"/>
            <a:ext cx="9144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1.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Principal component analysis (PCA)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of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he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normalized transcription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counts 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within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he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hree experimental groups (SH, IR and IS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).</a:t>
            </a:r>
            <a:endParaRPr lang="ru-RU" altLang="ru-RU" sz="1200" b="1" dirty="0">
              <a:latin typeface="Arial" panose="020B0604020202020204" pitchFamily="34" charset="0"/>
              <a:ea typeface="Calibri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4140" y="6021288"/>
            <a:ext cx="891572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ru-RU" sz="1200" dirty="0">
                <a:latin typeface="Arial" panose="020B0604020202020204" pitchFamily="34" charset="0"/>
                <a:cs typeface="Arial" panose="020B0604020202020204" pitchFamily="34" charset="0"/>
              </a:rPr>
              <a:t>PCA </a:t>
            </a:r>
            <a:r>
              <a:rPr lang="en-US" altLang="ru-RU" sz="1200" dirty="0">
                <a:latin typeface="Arial" panose="020B0604020202020204" pitchFamily="34" charset="0"/>
                <a:cs typeface="Arial" panose="020B0604020202020204" pitchFamily="34" charset="0"/>
              </a:rPr>
              <a:t>used FPKM dat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ac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ints represent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. Red, green 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ue points represent rats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H, IR and IS group, respectively.</a:t>
            </a:r>
            <a:endParaRPr lang="ru-R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 descr="J:\Редактируемые\Для публикаций\0_текущие публикации\ПГП, ПГПЛ\вар2\Genes\раунд1\reads_PCA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268760"/>
            <a:ext cx="8080451" cy="38085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55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1</cp:revision>
  <dcterms:created xsi:type="dcterms:W3CDTF">2020-12-07T15:35:27Z</dcterms:created>
  <dcterms:modified xsi:type="dcterms:W3CDTF">2022-12-09T15:52:17Z</dcterms:modified>
</cp:coreProperties>
</file>